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8" r:id="rId1"/>
  </p:sldMasterIdLst>
  <p:notesMasterIdLst>
    <p:notesMasterId r:id="rId3"/>
  </p:notesMasterIdLst>
  <p:sldIdLst>
    <p:sldId id="257"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FD47BBB-CBF5-8739-C251-EE41AE33BBBB}" v="4" dt="2023-08-18T20:23:48.19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52" d="100"/>
          <a:sy n="52" d="100"/>
        </p:scale>
        <p:origin x="2506" y="4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lim, Chinnu" userId="S::chisalim@iu.edu::97f0121d-12bb-4de1-b0c3-9497d3c11a4c" providerId="AD" clId="Web-{5A444016-A950-D8C8-A2C8-0DF12AD44847}"/>
    <pc:docChg chg="modSld">
      <pc:chgData name="Salim, Chinnu" userId="S::chisalim@iu.edu::97f0121d-12bb-4de1-b0c3-9497d3c11a4c" providerId="AD" clId="Web-{5A444016-A950-D8C8-A2C8-0DF12AD44847}" dt="2023-03-22T19:58:25.993" v="14" actId="1076"/>
      <pc:docMkLst>
        <pc:docMk/>
      </pc:docMkLst>
      <pc:sldChg chg="addSp delSp modSp">
        <pc:chgData name="Salim, Chinnu" userId="S::chisalim@iu.edu::97f0121d-12bb-4de1-b0c3-9497d3c11a4c" providerId="AD" clId="Web-{5A444016-A950-D8C8-A2C8-0DF12AD44847}" dt="2023-03-22T19:58:25.993" v="14" actId="1076"/>
        <pc:sldMkLst>
          <pc:docMk/>
          <pc:sldMk cId="4017803071" sldId="256"/>
        </pc:sldMkLst>
        <pc:spChg chg="add del mod">
          <ac:chgData name="Salim, Chinnu" userId="S::chisalim@iu.edu::97f0121d-12bb-4de1-b0c3-9497d3c11a4c" providerId="AD" clId="Web-{5A444016-A950-D8C8-A2C8-0DF12AD44847}" dt="2023-03-22T19:09:37.025" v="10"/>
          <ac:spMkLst>
            <pc:docMk/>
            <pc:sldMk cId="4017803071" sldId="256"/>
            <ac:spMk id="4" creationId="{CAE95613-2B3F-6E2C-8080-3D2DD06534C2}"/>
          </ac:spMkLst>
        </pc:spChg>
        <pc:spChg chg="mod">
          <ac:chgData name="Salim, Chinnu" userId="S::chisalim@iu.edu::97f0121d-12bb-4de1-b0c3-9497d3c11a4c" providerId="AD" clId="Web-{5A444016-A950-D8C8-A2C8-0DF12AD44847}" dt="2023-03-22T18:33:27.056" v="7" actId="1076"/>
          <ac:spMkLst>
            <pc:docMk/>
            <pc:sldMk cId="4017803071" sldId="256"/>
            <ac:spMk id="6" creationId="{55127381-C2F8-5633-0655-B58217238082}"/>
          </ac:spMkLst>
        </pc:spChg>
        <pc:picChg chg="mod">
          <ac:chgData name="Salim, Chinnu" userId="S::chisalim@iu.edu::97f0121d-12bb-4de1-b0c3-9497d3c11a4c" providerId="AD" clId="Web-{5A444016-A950-D8C8-A2C8-0DF12AD44847}" dt="2023-03-22T19:58:25.993" v="14" actId="1076"/>
          <ac:picMkLst>
            <pc:docMk/>
            <pc:sldMk cId="4017803071" sldId="256"/>
            <ac:picMk id="3" creationId="{BF74C021-83BD-BB7F-625E-CE345B3C7026}"/>
          </ac:picMkLst>
        </pc:picChg>
      </pc:sldChg>
      <pc:sldChg chg="modSp">
        <pc:chgData name="Salim, Chinnu" userId="S::chisalim@iu.edu::97f0121d-12bb-4de1-b0c3-9497d3c11a4c" providerId="AD" clId="Web-{5A444016-A950-D8C8-A2C8-0DF12AD44847}" dt="2023-03-22T19:58:16.508" v="13" actId="20577"/>
        <pc:sldMkLst>
          <pc:docMk/>
          <pc:sldMk cId="288543358" sldId="258"/>
        </pc:sldMkLst>
        <pc:spChg chg="mod">
          <ac:chgData name="Salim, Chinnu" userId="S::chisalim@iu.edu::97f0121d-12bb-4de1-b0c3-9497d3c11a4c" providerId="AD" clId="Web-{5A444016-A950-D8C8-A2C8-0DF12AD44847}" dt="2023-03-22T19:58:16.508" v="13" actId="20577"/>
          <ac:spMkLst>
            <pc:docMk/>
            <pc:sldMk cId="288543358" sldId="258"/>
            <ac:spMk id="7" creationId="{04D67A3E-B03D-19D7-7690-E78FEB45FDF3}"/>
          </ac:spMkLst>
        </pc:spChg>
      </pc:sldChg>
    </pc:docChg>
  </pc:docChgLst>
  <pc:docChgLst>
    <pc:chgData name="Salim, Chinnu" userId="S::chisalim@iu.edu::97f0121d-12bb-4de1-b0c3-9497d3c11a4c" providerId="AD" clId="Web-{FF0FBE18-B0D1-2026-7E45-E6BB83AF8060}"/>
    <pc:docChg chg="modSld">
      <pc:chgData name="Salim, Chinnu" userId="S::chisalim@iu.edu::97f0121d-12bb-4de1-b0c3-9497d3c11a4c" providerId="AD" clId="Web-{FF0FBE18-B0D1-2026-7E45-E6BB83AF8060}" dt="2023-03-01T19:19:18.802" v="36" actId="1076"/>
      <pc:docMkLst>
        <pc:docMk/>
      </pc:docMkLst>
      <pc:sldChg chg="addSp delSp modSp">
        <pc:chgData name="Salim, Chinnu" userId="S::chisalim@iu.edu::97f0121d-12bb-4de1-b0c3-9497d3c11a4c" providerId="AD" clId="Web-{FF0FBE18-B0D1-2026-7E45-E6BB83AF8060}" dt="2023-03-01T19:13:49.607" v="11" actId="1076"/>
        <pc:sldMkLst>
          <pc:docMk/>
          <pc:sldMk cId="4017803071" sldId="256"/>
        </pc:sldMkLst>
        <pc:picChg chg="add mod">
          <ac:chgData name="Salim, Chinnu" userId="S::chisalim@iu.edu::97f0121d-12bb-4de1-b0c3-9497d3c11a4c" providerId="AD" clId="Web-{FF0FBE18-B0D1-2026-7E45-E6BB83AF8060}" dt="2023-03-01T19:13:49.607" v="11" actId="1076"/>
          <ac:picMkLst>
            <pc:docMk/>
            <pc:sldMk cId="4017803071" sldId="256"/>
            <ac:picMk id="3" creationId="{BF74C021-83BD-BB7F-625E-CE345B3C7026}"/>
          </ac:picMkLst>
        </pc:picChg>
        <pc:picChg chg="del">
          <ac:chgData name="Salim, Chinnu" userId="S::chisalim@iu.edu::97f0121d-12bb-4de1-b0c3-9497d3c11a4c" providerId="AD" clId="Web-{FF0FBE18-B0D1-2026-7E45-E6BB83AF8060}" dt="2023-03-01T19:10:43.274" v="0"/>
          <ac:picMkLst>
            <pc:docMk/>
            <pc:sldMk cId="4017803071" sldId="256"/>
            <ac:picMk id="5" creationId="{7D5348C7-9FCD-789D-B2F2-79B15C608A18}"/>
          </ac:picMkLst>
        </pc:picChg>
      </pc:sldChg>
      <pc:sldChg chg="modSp">
        <pc:chgData name="Salim, Chinnu" userId="S::chisalim@iu.edu::97f0121d-12bb-4de1-b0c3-9497d3c11a4c" providerId="AD" clId="Web-{FF0FBE18-B0D1-2026-7E45-E6BB83AF8060}" dt="2023-03-01T19:11:06.509" v="3" actId="1076"/>
        <pc:sldMkLst>
          <pc:docMk/>
          <pc:sldMk cId="332695274" sldId="257"/>
        </pc:sldMkLst>
        <pc:grpChg chg="mod">
          <ac:chgData name="Salim, Chinnu" userId="S::chisalim@iu.edu::97f0121d-12bb-4de1-b0c3-9497d3c11a4c" providerId="AD" clId="Web-{FF0FBE18-B0D1-2026-7E45-E6BB83AF8060}" dt="2023-03-01T19:11:06.509" v="3" actId="1076"/>
          <ac:grpSpMkLst>
            <pc:docMk/>
            <pc:sldMk cId="332695274" sldId="257"/>
            <ac:grpSpMk id="26" creationId="{10754A8B-6964-2DD2-CFE9-D6CC96D3FC7C}"/>
          </ac:grpSpMkLst>
        </pc:grpChg>
      </pc:sldChg>
      <pc:sldChg chg="addSp delSp modSp">
        <pc:chgData name="Salim, Chinnu" userId="S::chisalim@iu.edu::97f0121d-12bb-4de1-b0c3-9497d3c11a4c" providerId="AD" clId="Web-{FF0FBE18-B0D1-2026-7E45-E6BB83AF8060}" dt="2023-03-01T19:19:18.802" v="36" actId="1076"/>
        <pc:sldMkLst>
          <pc:docMk/>
          <pc:sldMk cId="288543358" sldId="258"/>
        </pc:sldMkLst>
        <pc:spChg chg="mod">
          <ac:chgData name="Salim, Chinnu" userId="S::chisalim@iu.edu::97f0121d-12bb-4de1-b0c3-9497d3c11a4c" providerId="AD" clId="Web-{FF0FBE18-B0D1-2026-7E45-E6BB83AF8060}" dt="2023-03-01T19:19:18.802" v="36" actId="1076"/>
          <ac:spMkLst>
            <pc:docMk/>
            <pc:sldMk cId="288543358" sldId="258"/>
            <ac:spMk id="7" creationId="{04D67A3E-B03D-19D7-7690-E78FEB45FDF3}"/>
          </ac:spMkLst>
        </pc:spChg>
        <pc:grpChg chg="del">
          <ac:chgData name="Salim, Chinnu" userId="S::chisalim@iu.edu::97f0121d-12bb-4de1-b0c3-9497d3c11a4c" providerId="AD" clId="Web-{FF0FBE18-B0D1-2026-7E45-E6BB83AF8060}" dt="2023-03-01T19:14:03.045" v="12"/>
          <ac:grpSpMkLst>
            <pc:docMk/>
            <pc:sldMk cId="288543358" sldId="258"/>
            <ac:grpSpMk id="18" creationId="{138E6232-B2D3-4845-A229-EF482531C276}"/>
          </ac:grpSpMkLst>
        </pc:grpChg>
        <pc:picChg chg="add del mod">
          <ac:chgData name="Salim, Chinnu" userId="S::chisalim@iu.edu::97f0121d-12bb-4de1-b0c3-9497d3c11a4c" providerId="AD" clId="Web-{FF0FBE18-B0D1-2026-7E45-E6BB83AF8060}" dt="2023-03-01T19:14:26.842" v="15"/>
          <ac:picMkLst>
            <pc:docMk/>
            <pc:sldMk cId="288543358" sldId="258"/>
            <ac:picMk id="3" creationId="{A06C4993-DAF0-964C-70AE-6D96759D5BC3}"/>
          </ac:picMkLst>
        </pc:picChg>
        <pc:picChg chg="add del mod">
          <ac:chgData name="Salim, Chinnu" userId="S::chisalim@iu.edu::97f0121d-12bb-4de1-b0c3-9497d3c11a4c" providerId="AD" clId="Web-{FF0FBE18-B0D1-2026-7E45-E6BB83AF8060}" dt="2023-03-01T19:15:23.828" v="19"/>
          <ac:picMkLst>
            <pc:docMk/>
            <pc:sldMk cId="288543358" sldId="258"/>
            <ac:picMk id="4" creationId="{6BD9311E-960B-6753-D61F-5067C94C0A9F}"/>
          </ac:picMkLst>
        </pc:picChg>
        <pc:picChg chg="add del mod">
          <ac:chgData name="Salim, Chinnu" userId="S::chisalim@iu.edu::97f0121d-12bb-4de1-b0c3-9497d3c11a4c" providerId="AD" clId="Web-{FF0FBE18-B0D1-2026-7E45-E6BB83AF8060}" dt="2023-03-01T19:18:14.941" v="27"/>
          <ac:picMkLst>
            <pc:docMk/>
            <pc:sldMk cId="288543358" sldId="258"/>
            <ac:picMk id="5" creationId="{EE41C7A4-86AE-E0A1-A68C-51729C76CA09}"/>
          </ac:picMkLst>
        </pc:picChg>
        <pc:picChg chg="add mod">
          <ac:chgData name="Salim, Chinnu" userId="S::chisalim@iu.edu::97f0121d-12bb-4de1-b0c3-9497d3c11a4c" providerId="AD" clId="Web-{FF0FBE18-B0D1-2026-7E45-E6BB83AF8060}" dt="2023-03-01T19:19:14.802" v="35" actId="1076"/>
          <ac:picMkLst>
            <pc:docMk/>
            <pc:sldMk cId="288543358" sldId="258"/>
            <ac:picMk id="8" creationId="{F3A93107-0411-B9DA-21C7-FC414017B16B}"/>
          </ac:picMkLst>
        </pc:picChg>
      </pc:sldChg>
    </pc:docChg>
  </pc:docChgLst>
  <pc:docChgLst>
    <pc:chgData name="Dhakal, Alfa" userId="S::aldhakal@iu.edu::47175381-e0f0-42f2-a909-d585e2a70e98" providerId="AD" clId="Web-{C9769094-1664-7458-3467-0ACCADE5B132}"/>
    <pc:docChg chg="modSld">
      <pc:chgData name="Dhakal, Alfa" userId="S::aldhakal@iu.edu::47175381-e0f0-42f2-a909-d585e2a70e98" providerId="AD" clId="Web-{C9769094-1664-7458-3467-0ACCADE5B132}" dt="2023-03-01T18:22:12.641" v="1" actId="20577"/>
      <pc:docMkLst>
        <pc:docMk/>
      </pc:docMkLst>
      <pc:sldChg chg="modSp">
        <pc:chgData name="Dhakal, Alfa" userId="S::aldhakal@iu.edu::47175381-e0f0-42f2-a909-d585e2a70e98" providerId="AD" clId="Web-{C9769094-1664-7458-3467-0ACCADE5B132}" dt="2023-03-01T18:22:12.641" v="1" actId="20577"/>
        <pc:sldMkLst>
          <pc:docMk/>
          <pc:sldMk cId="4017803071" sldId="256"/>
        </pc:sldMkLst>
        <pc:spChg chg="mod">
          <ac:chgData name="Dhakal, Alfa" userId="S::aldhakal@iu.edu::47175381-e0f0-42f2-a909-d585e2a70e98" providerId="AD" clId="Web-{C9769094-1664-7458-3467-0ACCADE5B132}" dt="2023-03-01T18:22:12.641" v="1" actId="20577"/>
          <ac:spMkLst>
            <pc:docMk/>
            <pc:sldMk cId="4017803071" sldId="256"/>
            <ac:spMk id="6" creationId="{55127381-C2F8-5633-0655-B58217238082}"/>
          </ac:spMkLst>
        </pc:spChg>
      </pc:sldChg>
    </pc:docChg>
  </pc:docChgLst>
  <pc:docChgLst>
    <pc:chgData name="Salim, Chinnu" userId="S::chisalim@iu.edu::97f0121d-12bb-4de1-b0c3-9497d3c11a4c" providerId="AD" clId="Web-{55546C5B-AE20-B4B7-E9FE-9415B410AA6B}"/>
    <pc:docChg chg="modSld">
      <pc:chgData name="Salim, Chinnu" userId="S::chisalim@iu.edu::97f0121d-12bb-4de1-b0c3-9497d3c11a4c" providerId="AD" clId="Web-{55546C5B-AE20-B4B7-E9FE-9415B410AA6B}" dt="2023-03-22T03:44:25.376" v="24"/>
      <pc:docMkLst>
        <pc:docMk/>
      </pc:docMkLst>
      <pc:sldChg chg="modSp">
        <pc:chgData name="Salim, Chinnu" userId="S::chisalim@iu.edu::97f0121d-12bb-4de1-b0c3-9497d3c11a4c" providerId="AD" clId="Web-{55546C5B-AE20-B4B7-E9FE-9415B410AA6B}" dt="2023-03-22T03:43:50.671" v="22" actId="20577"/>
        <pc:sldMkLst>
          <pc:docMk/>
          <pc:sldMk cId="4017803071" sldId="256"/>
        </pc:sldMkLst>
        <pc:spChg chg="mod">
          <ac:chgData name="Salim, Chinnu" userId="S::chisalim@iu.edu::97f0121d-12bb-4de1-b0c3-9497d3c11a4c" providerId="AD" clId="Web-{55546C5B-AE20-B4B7-E9FE-9415B410AA6B}" dt="2023-03-22T03:43:50.671" v="22" actId="20577"/>
          <ac:spMkLst>
            <pc:docMk/>
            <pc:sldMk cId="4017803071" sldId="256"/>
            <ac:spMk id="2" creationId="{BF19D0C4-32CD-1272-4AEF-CB6B76937887}"/>
          </ac:spMkLst>
        </pc:spChg>
        <pc:spChg chg="mod">
          <ac:chgData name="Salim, Chinnu" userId="S::chisalim@iu.edu::97f0121d-12bb-4de1-b0c3-9497d3c11a4c" providerId="AD" clId="Web-{55546C5B-AE20-B4B7-E9FE-9415B410AA6B}" dt="2023-03-22T03:34:59.874" v="18" actId="20577"/>
          <ac:spMkLst>
            <pc:docMk/>
            <pc:sldMk cId="4017803071" sldId="256"/>
            <ac:spMk id="6" creationId="{55127381-C2F8-5633-0655-B58217238082}"/>
          </ac:spMkLst>
        </pc:spChg>
      </pc:sldChg>
      <pc:sldChg chg="delSp modSp">
        <pc:chgData name="Salim, Chinnu" userId="S::chisalim@iu.edu::97f0121d-12bb-4de1-b0c3-9497d3c11a4c" providerId="AD" clId="Web-{55546C5B-AE20-B4B7-E9FE-9415B410AA6B}" dt="2023-03-22T03:44:10.063" v="23"/>
        <pc:sldMkLst>
          <pc:docMk/>
          <pc:sldMk cId="332695274" sldId="257"/>
        </pc:sldMkLst>
        <pc:spChg chg="mod">
          <ac:chgData name="Salim, Chinnu" userId="S::chisalim@iu.edu::97f0121d-12bb-4de1-b0c3-9497d3c11a4c" providerId="AD" clId="Web-{55546C5B-AE20-B4B7-E9FE-9415B410AA6B}" dt="2023-03-22T03:34:23.091" v="17" actId="20577"/>
          <ac:spMkLst>
            <pc:docMk/>
            <pc:sldMk cId="332695274" sldId="257"/>
            <ac:spMk id="2" creationId="{25445CD6-AE6F-76D9-16C5-9EA1DC66FEA5}"/>
          </ac:spMkLst>
        </pc:spChg>
        <pc:spChg chg="del">
          <ac:chgData name="Salim, Chinnu" userId="S::chisalim@iu.edu::97f0121d-12bb-4de1-b0c3-9497d3c11a4c" providerId="AD" clId="Web-{55546C5B-AE20-B4B7-E9FE-9415B410AA6B}" dt="2023-03-22T03:44:10.063" v="23"/>
          <ac:spMkLst>
            <pc:docMk/>
            <pc:sldMk cId="332695274" sldId="257"/>
            <ac:spMk id="3" creationId="{2B9C647D-F5BE-C399-F0D7-F6DA9396E9C8}"/>
          </ac:spMkLst>
        </pc:spChg>
      </pc:sldChg>
      <pc:sldChg chg="delSp modSp">
        <pc:chgData name="Salim, Chinnu" userId="S::chisalim@iu.edu::97f0121d-12bb-4de1-b0c3-9497d3c11a4c" providerId="AD" clId="Web-{55546C5B-AE20-B4B7-E9FE-9415B410AA6B}" dt="2023-03-22T03:44:25.376" v="24"/>
        <pc:sldMkLst>
          <pc:docMk/>
          <pc:sldMk cId="288543358" sldId="258"/>
        </pc:sldMkLst>
        <pc:spChg chg="del">
          <ac:chgData name="Salim, Chinnu" userId="S::chisalim@iu.edu::97f0121d-12bb-4de1-b0c3-9497d3c11a4c" providerId="AD" clId="Web-{55546C5B-AE20-B4B7-E9FE-9415B410AA6B}" dt="2023-03-22T03:44:25.376" v="24"/>
          <ac:spMkLst>
            <pc:docMk/>
            <pc:sldMk cId="288543358" sldId="258"/>
            <ac:spMk id="2" creationId="{BCBFBA4D-0249-A21D-8433-BCB04C33E1DA}"/>
          </ac:spMkLst>
        </pc:spChg>
        <pc:spChg chg="mod">
          <ac:chgData name="Salim, Chinnu" userId="S::chisalim@iu.edu::97f0121d-12bb-4de1-b0c3-9497d3c11a4c" providerId="AD" clId="Web-{55546C5B-AE20-B4B7-E9FE-9415B410AA6B}" dt="2023-03-22T03:33:57.091" v="15" actId="20577"/>
          <ac:spMkLst>
            <pc:docMk/>
            <pc:sldMk cId="288543358" sldId="258"/>
            <ac:spMk id="7" creationId="{04D67A3E-B03D-19D7-7690-E78FEB45FDF3}"/>
          </ac:spMkLst>
        </pc:spChg>
      </pc:sldChg>
    </pc:docChg>
  </pc:docChgLst>
  <pc:docChgLst>
    <pc:chgData clId="Web-{6E034CE8-3FC2-B04F-C318-C9D88F07C726}"/>
    <pc:docChg chg="modSld">
      <pc:chgData name="" userId="" providerId="" clId="Web-{6E034CE8-3FC2-B04F-C318-C9D88F07C726}" dt="2023-07-18T04:04:56.609" v="0" actId="20577"/>
      <pc:docMkLst>
        <pc:docMk/>
      </pc:docMkLst>
      <pc:sldChg chg="modSp">
        <pc:chgData name="" userId="" providerId="" clId="Web-{6E034CE8-3FC2-B04F-C318-C9D88F07C726}" dt="2023-07-18T04:04:56.609" v="0" actId="20577"/>
        <pc:sldMkLst>
          <pc:docMk/>
          <pc:sldMk cId="332695274" sldId="257"/>
        </pc:sldMkLst>
        <pc:spChg chg="mod">
          <ac:chgData name="" userId="" providerId="" clId="Web-{6E034CE8-3FC2-B04F-C318-C9D88F07C726}" dt="2023-07-18T04:04:56.609" v="0" actId="20577"/>
          <ac:spMkLst>
            <pc:docMk/>
            <pc:sldMk cId="332695274" sldId="257"/>
            <ac:spMk id="2" creationId="{25445CD6-AE6F-76D9-16C5-9EA1DC66FEA5}"/>
          </ac:spMkLst>
        </pc:spChg>
      </pc:sldChg>
    </pc:docChg>
  </pc:docChgLst>
  <pc:docChgLst>
    <pc:chgData name="Hundley, Heather Ann" userId="9923bbf4-35ca-4515-b4c1-83653bfb90e1" providerId="ADAL" clId="{E0A4164F-1C22-714F-B7B1-81E693B09076}"/>
    <pc:docChg chg="modSld">
      <pc:chgData name="Hundley, Heather Ann" userId="9923bbf4-35ca-4515-b4c1-83653bfb90e1" providerId="ADAL" clId="{E0A4164F-1C22-714F-B7B1-81E693B09076}" dt="2023-08-02T14:07:17.771" v="3" actId="20577"/>
      <pc:docMkLst>
        <pc:docMk/>
      </pc:docMkLst>
      <pc:sldChg chg="modSp mod">
        <pc:chgData name="Hundley, Heather Ann" userId="9923bbf4-35ca-4515-b4c1-83653bfb90e1" providerId="ADAL" clId="{E0A4164F-1C22-714F-B7B1-81E693B09076}" dt="2023-08-02T14:07:17.771" v="3" actId="20577"/>
        <pc:sldMkLst>
          <pc:docMk/>
          <pc:sldMk cId="332695274" sldId="257"/>
        </pc:sldMkLst>
        <pc:spChg chg="mod">
          <ac:chgData name="Hundley, Heather Ann" userId="9923bbf4-35ca-4515-b4c1-83653bfb90e1" providerId="ADAL" clId="{E0A4164F-1C22-714F-B7B1-81E693B09076}" dt="2023-08-02T14:07:17.771" v="3" actId="20577"/>
          <ac:spMkLst>
            <pc:docMk/>
            <pc:sldMk cId="332695274" sldId="257"/>
            <ac:spMk id="2" creationId="{25445CD6-AE6F-76D9-16C5-9EA1DC66FEA5}"/>
          </ac:spMkLst>
        </pc:spChg>
      </pc:sldChg>
    </pc:docChg>
  </pc:docChgLst>
  <pc:docChgLst>
    <pc:chgData name="Salim, Chinnu" userId="S::chisalim@iu.edu::97f0121d-12bb-4de1-b0c3-9497d3c11a4c" providerId="AD" clId="Web-{6E034CE8-3FC2-B04F-C318-C9D88F07C726}"/>
    <pc:docChg chg="modSld">
      <pc:chgData name="Salim, Chinnu" userId="S::chisalim@iu.edu::97f0121d-12bb-4de1-b0c3-9497d3c11a4c" providerId="AD" clId="Web-{6E034CE8-3FC2-B04F-C318-C9D88F07C726}" dt="2023-07-18T04:05:01.812" v="0" actId="20577"/>
      <pc:docMkLst>
        <pc:docMk/>
      </pc:docMkLst>
      <pc:sldChg chg="modSp">
        <pc:chgData name="Salim, Chinnu" userId="S::chisalim@iu.edu::97f0121d-12bb-4de1-b0c3-9497d3c11a4c" providerId="AD" clId="Web-{6E034CE8-3FC2-B04F-C318-C9D88F07C726}" dt="2023-07-18T04:05:01.812" v="0" actId="20577"/>
        <pc:sldMkLst>
          <pc:docMk/>
          <pc:sldMk cId="332695274" sldId="257"/>
        </pc:sldMkLst>
        <pc:spChg chg="mod">
          <ac:chgData name="Salim, Chinnu" userId="S::chisalim@iu.edu::97f0121d-12bb-4de1-b0c3-9497d3c11a4c" providerId="AD" clId="Web-{6E034CE8-3FC2-B04F-C318-C9D88F07C726}" dt="2023-07-18T04:05:01.812" v="0" actId="20577"/>
          <ac:spMkLst>
            <pc:docMk/>
            <pc:sldMk cId="332695274" sldId="257"/>
            <ac:spMk id="2" creationId="{25445CD6-AE6F-76D9-16C5-9EA1DC66FEA5}"/>
          </ac:spMkLst>
        </pc:spChg>
      </pc:sldChg>
    </pc:docChg>
  </pc:docChgLst>
  <pc:docChgLst>
    <pc:chgData name="Hundley, Heather Ann" userId="9923bbf4-35ca-4515-b4c1-83653bfb90e1" providerId="ADAL" clId="{52BE092E-D39D-3940-8365-860EC0F7B2C6}"/>
    <pc:docChg chg="modSld">
      <pc:chgData name="Hundley, Heather Ann" userId="9923bbf4-35ca-4515-b4c1-83653bfb90e1" providerId="ADAL" clId="{52BE092E-D39D-3940-8365-860EC0F7B2C6}" dt="2023-03-24T15:36:15.415" v="15" actId="20577"/>
      <pc:docMkLst>
        <pc:docMk/>
      </pc:docMkLst>
      <pc:sldChg chg="modSp mod">
        <pc:chgData name="Hundley, Heather Ann" userId="9923bbf4-35ca-4515-b4c1-83653bfb90e1" providerId="ADAL" clId="{52BE092E-D39D-3940-8365-860EC0F7B2C6}" dt="2023-03-24T15:36:15.415" v="15" actId="20577"/>
        <pc:sldMkLst>
          <pc:docMk/>
          <pc:sldMk cId="332695274" sldId="257"/>
        </pc:sldMkLst>
        <pc:spChg chg="mod">
          <ac:chgData name="Hundley, Heather Ann" userId="9923bbf4-35ca-4515-b4c1-83653bfb90e1" providerId="ADAL" clId="{52BE092E-D39D-3940-8365-860EC0F7B2C6}" dt="2023-03-24T15:36:15.415" v="15" actId="20577"/>
          <ac:spMkLst>
            <pc:docMk/>
            <pc:sldMk cId="332695274" sldId="257"/>
            <ac:spMk id="2" creationId="{25445CD6-AE6F-76D9-16C5-9EA1DC66FEA5}"/>
          </ac:spMkLst>
        </pc:spChg>
      </pc:sldChg>
    </pc:docChg>
  </pc:docChgLst>
  <pc:docChgLst>
    <pc:chgData name="Salim, Chinnu" userId="S::chisalim@iu.edu::97f0121d-12bb-4de1-b0c3-9497d3c11a4c" providerId="AD" clId="Web-{BB2CEBBB-9A44-929B-BF5D-DB6C526AF12D}"/>
    <pc:docChg chg="modSld">
      <pc:chgData name="Salim, Chinnu" userId="S::chisalim@iu.edu::97f0121d-12bb-4de1-b0c3-9497d3c11a4c" providerId="AD" clId="Web-{BB2CEBBB-9A44-929B-BF5D-DB6C526AF12D}" dt="2023-03-22T20:10:01.107" v="8" actId="1076"/>
      <pc:docMkLst>
        <pc:docMk/>
      </pc:docMkLst>
      <pc:sldChg chg="addSp delSp modSp">
        <pc:chgData name="Salim, Chinnu" userId="S::chisalim@iu.edu::97f0121d-12bb-4de1-b0c3-9497d3c11a4c" providerId="AD" clId="Web-{BB2CEBBB-9A44-929B-BF5D-DB6C526AF12D}" dt="2023-03-22T20:10:01.107" v="8" actId="1076"/>
        <pc:sldMkLst>
          <pc:docMk/>
          <pc:sldMk cId="4017803071" sldId="256"/>
        </pc:sldMkLst>
        <pc:spChg chg="mod">
          <ac:chgData name="Salim, Chinnu" userId="S::chisalim@iu.edu::97f0121d-12bb-4de1-b0c3-9497d3c11a4c" providerId="AD" clId="Web-{BB2CEBBB-9A44-929B-BF5D-DB6C526AF12D}" dt="2023-03-22T20:10:01.107" v="8" actId="1076"/>
          <ac:spMkLst>
            <pc:docMk/>
            <pc:sldMk cId="4017803071" sldId="256"/>
            <ac:spMk id="6" creationId="{55127381-C2F8-5633-0655-B58217238082}"/>
          </ac:spMkLst>
        </pc:spChg>
        <pc:picChg chg="del">
          <ac:chgData name="Salim, Chinnu" userId="S::chisalim@iu.edu::97f0121d-12bb-4de1-b0c3-9497d3c11a4c" providerId="AD" clId="Web-{BB2CEBBB-9A44-929B-BF5D-DB6C526AF12D}" dt="2023-03-22T20:09:33.903" v="0"/>
          <ac:picMkLst>
            <pc:docMk/>
            <pc:sldMk cId="4017803071" sldId="256"/>
            <ac:picMk id="3" creationId="{BF74C021-83BD-BB7F-625E-CE345B3C7026}"/>
          </ac:picMkLst>
        </pc:picChg>
        <pc:picChg chg="add mod">
          <ac:chgData name="Salim, Chinnu" userId="S::chisalim@iu.edu::97f0121d-12bb-4de1-b0c3-9497d3c11a4c" providerId="AD" clId="Web-{BB2CEBBB-9A44-929B-BF5D-DB6C526AF12D}" dt="2023-03-22T20:09:55.372" v="7" actId="14100"/>
          <ac:picMkLst>
            <pc:docMk/>
            <pc:sldMk cId="4017803071" sldId="256"/>
            <ac:picMk id="4" creationId="{F77B9F6A-E622-3B63-4450-58870593455F}"/>
          </ac:picMkLst>
        </pc:picChg>
      </pc:sldChg>
    </pc:docChg>
  </pc:docChgLst>
  <pc:docChgLst>
    <pc:chgData name="Salim, Chinnu" userId="S::chisalim@iu.edu::97f0121d-12bb-4de1-b0c3-9497d3c11a4c" providerId="AD" clId="Web-{51E1042F-247A-4FB8-ADEB-844842AFBF06}"/>
    <pc:docChg chg="modSld">
      <pc:chgData name="Salim, Chinnu" userId="S::chisalim@iu.edu::97f0121d-12bb-4de1-b0c3-9497d3c11a4c" providerId="AD" clId="Web-{51E1042F-247A-4FB8-ADEB-844842AFBF06}" dt="2023-03-22T03:28:52.355" v="31" actId="20577"/>
      <pc:docMkLst>
        <pc:docMk/>
      </pc:docMkLst>
      <pc:sldChg chg="modSp">
        <pc:chgData name="Salim, Chinnu" userId="S::chisalim@iu.edu::97f0121d-12bb-4de1-b0c3-9497d3c11a4c" providerId="AD" clId="Web-{51E1042F-247A-4FB8-ADEB-844842AFBF06}" dt="2023-03-22T03:28:52.355" v="31" actId="20577"/>
        <pc:sldMkLst>
          <pc:docMk/>
          <pc:sldMk cId="332695274" sldId="257"/>
        </pc:sldMkLst>
        <pc:spChg chg="mod">
          <ac:chgData name="Salim, Chinnu" userId="S::chisalim@iu.edu::97f0121d-12bb-4de1-b0c3-9497d3c11a4c" providerId="AD" clId="Web-{51E1042F-247A-4FB8-ADEB-844842AFBF06}" dt="2023-03-22T03:28:52.355" v="31" actId="20577"/>
          <ac:spMkLst>
            <pc:docMk/>
            <pc:sldMk cId="332695274" sldId="257"/>
            <ac:spMk id="2" creationId="{25445CD6-AE6F-76D9-16C5-9EA1DC66FEA5}"/>
          </ac:spMkLst>
        </pc:spChg>
      </pc:sldChg>
    </pc:docChg>
  </pc:docChgLst>
  <pc:docChgLst>
    <pc:chgData name="Salim, Chinnu" userId="S::chisalim@iu.edu::97f0121d-12bb-4de1-b0c3-9497d3c11a4c" providerId="AD" clId="Web-{BFD47BBB-CBF5-8739-C251-EE41AE33BBBB}"/>
    <pc:docChg chg="modSld">
      <pc:chgData name="Salim, Chinnu" userId="S::chisalim@iu.edu::97f0121d-12bb-4de1-b0c3-9497d3c11a4c" providerId="AD" clId="Web-{BFD47BBB-CBF5-8739-C251-EE41AE33BBBB}" dt="2023-08-18T20:23:45.980" v="0" actId="20577"/>
      <pc:docMkLst>
        <pc:docMk/>
      </pc:docMkLst>
      <pc:sldChg chg="modSp">
        <pc:chgData name="Salim, Chinnu" userId="S::chisalim@iu.edu::97f0121d-12bb-4de1-b0c3-9497d3c11a4c" providerId="AD" clId="Web-{BFD47BBB-CBF5-8739-C251-EE41AE33BBBB}" dt="2023-08-18T20:23:45.980" v="0" actId="20577"/>
        <pc:sldMkLst>
          <pc:docMk/>
          <pc:sldMk cId="332695274" sldId="257"/>
        </pc:sldMkLst>
        <pc:spChg chg="mod">
          <ac:chgData name="Salim, Chinnu" userId="S::chisalim@iu.edu::97f0121d-12bb-4de1-b0c3-9497d3c11a4c" providerId="AD" clId="Web-{BFD47BBB-CBF5-8739-C251-EE41AE33BBBB}" dt="2023-08-18T20:23:45.980" v="0" actId="20577"/>
          <ac:spMkLst>
            <pc:docMk/>
            <pc:sldMk cId="332695274" sldId="257"/>
            <ac:spMk id="2" creationId="{25445CD6-AE6F-76D9-16C5-9EA1DC66FEA5}"/>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6156153-8435-475E-82F8-D26DF3FBEEC5}" type="datetimeFigureOut">
              <a:rPr lang="en-US" smtClean="0"/>
              <a:t>11/27/2023</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D67C22-2072-4A7D-A443-5B07EF0AE4B9}" type="slidenum">
              <a:rPr lang="en-US" smtClean="0"/>
              <a:t>‹#›</a:t>
            </a:fld>
            <a:endParaRPr lang="en-US"/>
          </a:p>
        </p:txBody>
      </p:sp>
    </p:spTree>
    <p:extLst>
      <p:ext uri="{BB962C8B-B14F-4D97-AF65-F5344CB8AC3E}">
        <p14:creationId xmlns:p14="http://schemas.microsoft.com/office/powerpoint/2010/main" val="34889444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p>
        </p:txBody>
      </p:sp>
      <p:sp>
        <p:nvSpPr>
          <p:cNvPr id="4" name="Date Placeholder 3"/>
          <p:cNvSpPr>
            <a:spLocks noGrp="1"/>
          </p:cNvSpPr>
          <p:nvPr>
            <p:ph type="dt" sz="half" idx="10"/>
          </p:nvPr>
        </p:nvSpPr>
        <p:spPr/>
        <p:txBody>
          <a:bodyPr/>
          <a:lstStyle/>
          <a:p>
            <a:fld id="{2FB74D95-4025-FA49-8DBA-B2DA07A2040A}" type="datetimeFigureOut">
              <a:rPr lang="en-US" smtClean="0"/>
              <a:t>1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7226633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B74D95-4025-FA49-8DBA-B2DA07A2040A}" type="datetimeFigureOut">
              <a:rPr lang="en-US" smtClean="0"/>
              <a:t>1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0750495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B74D95-4025-FA49-8DBA-B2DA07A2040A}" type="datetimeFigureOut">
              <a:rPr lang="en-US" smtClean="0"/>
              <a:t>1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40095980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B74D95-4025-FA49-8DBA-B2DA07A2040A}" type="datetimeFigureOut">
              <a:rPr lang="en-US" smtClean="0"/>
              <a:t>1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0757331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FB74D95-4025-FA49-8DBA-B2DA07A2040A}" type="datetimeFigureOut">
              <a:rPr lang="en-US" smtClean="0"/>
              <a:t>1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9631545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FB74D95-4025-FA49-8DBA-B2DA07A2040A}" type="datetimeFigureOut">
              <a:rPr lang="en-US" smtClean="0"/>
              <a:t>1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23042005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FB74D95-4025-FA49-8DBA-B2DA07A2040A}" type="datetimeFigureOut">
              <a:rPr lang="en-US" smtClean="0"/>
              <a:t>11/2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9462209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FB74D95-4025-FA49-8DBA-B2DA07A2040A}" type="datetimeFigureOut">
              <a:rPr lang="en-US" smtClean="0"/>
              <a:t>11/2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5295416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B74D95-4025-FA49-8DBA-B2DA07A2040A}" type="datetimeFigureOut">
              <a:rPr lang="en-US" smtClean="0"/>
              <a:t>11/2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8445114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2FB74D95-4025-FA49-8DBA-B2DA07A2040A}" type="datetimeFigureOut">
              <a:rPr lang="en-US" smtClean="0"/>
              <a:t>1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30188333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2FB74D95-4025-FA49-8DBA-B2DA07A2040A}" type="datetimeFigureOut">
              <a:rPr lang="en-US" smtClean="0"/>
              <a:t>1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4D294F9-6F17-AF4D-A105-3A9D3049578C}" type="slidenum">
              <a:rPr lang="en-US" smtClean="0"/>
              <a:t>‹#›</a:t>
            </a:fld>
            <a:endParaRPr lang="en-US"/>
          </a:p>
        </p:txBody>
      </p:sp>
    </p:spTree>
    <p:extLst>
      <p:ext uri="{BB962C8B-B14F-4D97-AF65-F5344CB8AC3E}">
        <p14:creationId xmlns:p14="http://schemas.microsoft.com/office/powerpoint/2010/main" val="16815488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2FB74D95-4025-FA49-8DBA-B2DA07A2040A}" type="datetimeFigureOut">
              <a:rPr lang="en-US" smtClean="0"/>
              <a:t>11/27/20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C4D294F9-6F17-AF4D-A105-3A9D3049578C}" type="slidenum">
              <a:rPr lang="en-US" smtClean="0"/>
              <a:t>‹#›</a:t>
            </a:fld>
            <a:endParaRPr lang="en-US"/>
          </a:p>
        </p:txBody>
      </p:sp>
    </p:spTree>
    <p:extLst>
      <p:ext uri="{BB962C8B-B14F-4D97-AF65-F5344CB8AC3E}">
        <p14:creationId xmlns:p14="http://schemas.microsoft.com/office/powerpoint/2010/main" val="3551466828"/>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tiff"/><Relationship Id="rId1" Type="http://schemas.openxmlformats.org/officeDocument/2006/relationships/slideLayout" Target="../slideLayouts/slideLayout2.xml"/><Relationship Id="rId4"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5445CD6-AE6F-76D9-16C5-9EA1DC66FEA5}"/>
              </a:ext>
            </a:extLst>
          </p:cNvPr>
          <p:cNvSpPr txBox="1"/>
          <p:nvPr/>
        </p:nvSpPr>
        <p:spPr>
          <a:xfrm>
            <a:off x="107910" y="3940964"/>
            <a:ext cx="7073350" cy="1938992"/>
          </a:xfrm>
          <a:prstGeom prst="rect">
            <a:avLst/>
          </a:prstGeom>
          <a:noFill/>
        </p:spPr>
        <p:txBody>
          <a:bodyPr wrap="square" lIns="91440" tIns="45720" rIns="91440" bIns="45720" rtlCol="0" anchor="t">
            <a:spAutoFit/>
          </a:bodyPr>
          <a:lstStyle/>
          <a:p>
            <a:r>
              <a:rPr lang="en-US" sz="1200" b="1" dirty="0">
                <a:latin typeface="Arial"/>
                <a:ea typeface="Calibri"/>
                <a:cs typeface="Arial"/>
              </a:rPr>
              <a:t>Additional file</a:t>
            </a:r>
            <a:r>
              <a:rPr lang="en-US" sz="1200" b="1" dirty="0">
                <a:effectLst/>
                <a:latin typeface="Arial"/>
                <a:ea typeface="Calibri"/>
                <a:cs typeface="Arial"/>
              </a:rPr>
              <a:t> 5</a:t>
            </a:r>
            <a:r>
              <a:rPr lang="en-US" sz="1200" b="1" dirty="0">
                <a:latin typeface="Arial"/>
                <a:ea typeface="Calibri"/>
                <a:cs typeface="Arial"/>
              </a:rPr>
              <a:t>: Fig. </a:t>
            </a:r>
            <a:r>
              <a:rPr lang="en-US" sz="1200" b="1">
                <a:latin typeface="Arial"/>
                <a:ea typeface="Calibri"/>
                <a:cs typeface="Arial"/>
              </a:rPr>
              <a:t>S5</a:t>
            </a:r>
            <a:r>
              <a:rPr lang="en-US" sz="1200" b="1">
                <a:effectLst/>
                <a:latin typeface="Arial"/>
                <a:ea typeface="Calibri"/>
                <a:cs typeface="Arial"/>
              </a:rPr>
              <a:t>. </a:t>
            </a:r>
            <a:r>
              <a:rPr lang="en-US" sz="1200" b="1" dirty="0">
                <a:effectLst/>
                <a:latin typeface="Arial"/>
                <a:ea typeface="Calibri"/>
                <a:cs typeface="Arial"/>
              </a:rPr>
              <a:t>Presence</a:t>
            </a:r>
            <a:r>
              <a:rPr lang="en-US" sz="1200" b="1" dirty="0">
                <a:latin typeface="Arial"/>
                <a:ea typeface="Calibri"/>
                <a:cs typeface="Arial"/>
              </a:rPr>
              <a:t> of epitope</a:t>
            </a:r>
            <a:r>
              <a:rPr lang="en-US" sz="1200" b="1" dirty="0">
                <a:effectLst/>
                <a:latin typeface="Arial"/>
                <a:ea typeface="Calibri"/>
                <a:cs typeface="Arial"/>
              </a:rPr>
              <a:t> tags does not significantly </a:t>
            </a:r>
            <a:r>
              <a:rPr lang="en-US" sz="1200" b="1" dirty="0">
                <a:latin typeface="Arial"/>
                <a:ea typeface="Calibri"/>
                <a:cs typeface="Arial"/>
              </a:rPr>
              <a:t>alter chemotaxis behavior or RNA editing. </a:t>
            </a:r>
            <a:r>
              <a:rPr lang="en-US" sz="1200" dirty="0">
                <a:latin typeface="Arial"/>
                <a:ea typeface="Calibri"/>
                <a:cs typeface="Arial"/>
              </a:rPr>
              <a:t>A) Chemotaxis index was calculated for the indicated strains. The graph represents the mean of three technical replicates for each strain. Error bars represent SEM. Statistical significance was measured using unpaired Mann Whitney test</a:t>
            </a:r>
            <a:r>
              <a:rPr lang="en-US" sz="1200" i="1" dirty="0">
                <a:latin typeface="Arial"/>
                <a:ea typeface="Calibri"/>
                <a:cs typeface="Arial"/>
              </a:rPr>
              <a:t>. p</a:t>
            </a:r>
            <a:r>
              <a:rPr lang="en-US" sz="1200" dirty="0">
                <a:latin typeface="Arial"/>
                <a:ea typeface="Calibri"/>
                <a:cs typeface="Arial"/>
              </a:rPr>
              <a:t> value was not significant (ns) (</a:t>
            </a:r>
            <a:r>
              <a:rPr lang="en-US" sz="1200" i="1" dirty="0">
                <a:latin typeface="Arial"/>
                <a:ea typeface="Calibri"/>
                <a:cs typeface="Arial"/>
              </a:rPr>
              <a:t>p</a:t>
            </a:r>
            <a:r>
              <a:rPr lang="en-US" sz="1200" dirty="0">
                <a:latin typeface="Arial"/>
                <a:ea typeface="Calibri"/>
                <a:cs typeface="Arial"/>
              </a:rPr>
              <a:t>&gt;0.05). </a:t>
            </a:r>
            <a:r>
              <a:rPr lang="en-US" sz="1200" dirty="0">
                <a:latin typeface="Arial"/>
                <a:cs typeface="Arial"/>
              </a:rPr>
              <a:t>B) </a:t>
            </a:r>
            <a:r>
              <a:rPr lang="en-US" sz="1200" dirty="0">
                <a:effectLst/>
                <a:latin typeface="Arial"/>
                <a:ea typeface="Calibri"/>
                <a:cs typeface="Arial"/>
              </a:rPr>
              <a:t>The bar graph represents the average editing levels</a:t>
            </a:r>
            <a:r>
              <a:rPr lang="en-US" sz="1200" dirty="0">
                <a:latin typeface="Arial"/>
                <a:ea typeface="Calibri"/>
                <a:cs typeface="Arial"/>
              </a:rPr>
              <a:t> quantified from the Sanger sequencing traces (representative traces on right) from three biological replicates. Editing at site 164 within </a:t>
            </a:r>
            <a:r>
              <a:rPr lang="en-US" sz="1200" i="1" dirty="0">
                <a:latin typeface="Arial"/>
                <a:ea typeface="Calibri"/>
                <a:cs typeface="Arial"/>
              </a:rPr>
              <a:t>lam-2</a:t>
            </a:r>
            <a:r>
              <a:rPr lang="en-US" sz="1200" dirty="0">
                <a:latin typeface="Arial"/>
                <a:ea typeface="Calibri"/>
                <a:cs typeface="Arial"/>
              </a:rPr>
              <a:t>, which is a known ADR-1 regulated site (Washburn et al. 2014). E</a:t>
            </a:r>
            <a:r>
              <a:rPr lang="en-US" sz="1200" dirty="0">
                <a:effectLst/>
                <a:latin typeface="Arial"/>
                <a:ea typeface="Calibri"/>
                <a:cs typeface="Arial"/>
              </a:rPr>
              <a:t>rror bars</a:t>
            </a:r>
            <a:r>
              <a:rPr lang="en-US" sz="1200" dirty="0">
                <a:latin typeface="Arial"/>
                <a:ea typeface="Calibri"/>
                <a:cs typeface="Arial"/>
              </a:rPr>
              <a:t> represent the standard error of the mean (SEM)</a:t>
            </a:r>
            <a:r>
              <a:rPr lang="en-US" sz="1200" dirty="0">
                <a:effectLst/>
                <a:latin typeface="Arial"/>
                <a:ea typeface="Calibri"/>
                <a:cs typeface="Arial"/>
              </a:rPr>
              <a:t>. Statistical significance was determined using a one-way ANOVA, </a:t>
            </a:r>
            <a:r>
              <a:rPr lang="en-US" sz="1200" i="1" dirty="0">
                <a:latin typeface="Arial"/>
                <a:ea typeface="Calibri"/>
                <a:cs typeface="Arial"/>
              </a:rPr>
              <a:t>p</a:t>
            </a:r>
            <a:r>
              <a:rPr lang="en-US" sz="1200" dirty="0">
                <a:latin typeface="Arial"/>
                <a:ea typeface="Calibri"/>
                <a:cs typeface="Arial"/>
              </a:rPr>
              <a:t> value was not significant (ns) (</a:t>
            </a:r>
            <a:r>
              <a:rPr lang="en-US" sz="1200" i="1" dirty="0">
                <a:latin typeface="Arial"/>
                <a:ea typeface="Calibri"/>
                <a:cs typeface="Arial"/>
              </a:rPr>
              <a:t>p</a:t>
            </a:r>
            <a:r>
              <a:rPr lang="en-US" sz="1200" dirty="0">
                <a:latin typeface="Arial"/>
                <a:ea typeface="Calibri"/>
                <a:cs typeface="Arial"/>
              </a:rPr>
              <a:t>&gt;0.05)</a:t>
            </a:r>
            <a:r>
              <a:rPr lang="en-US" sz="1200" dirty="0">
                <a:effectLst/>
                <a:latin typeface="Arial"/>
                <a:ea typeface="Calibri"/>
                <a:cs typeface="Arial"/>
              </a:rPr>
              <a:t>.</a:t>
            </a:r>
            <a:r>
              <a:rPr lang="en-US" sz="1200" dirty="0">
                <a:latin typeface="Arial"/>
                <a:ea typeface="Calibri"/>
                <a:cs typeface="Arial"/>
              </a:rPr>
              <a:t> The nucleotides in the Sanger sequencing chromatogram are characterized by different colors (green, adenosine; black, guanosine; red, thymidine). </a:t>
            </a:r>
            <a:endParaRPr lang="en-US" sz="1200" dirty="0">
              <a:latin typeface="Arial" panose="020B0604020202020204" pitchFamily="34" charset="0"/>
              <a:ea typeface="Calibri"/>
              <a:cs typeface="Arial" panose="020B0604020202020204" pitchFamily="34" charset="0"/>
            </a:endParaRPr>
          </a:p>
        </p:txBody>
      </p:sp>
      <p:grpSp>
        <p:nvGrpSpPr>
          <p:cNvPr id="26" name="Group 25">
            <a:extLst>
              <a:ext uri="{FF2B5EF4-FFF2-40B4-BE49-F238E27FC236}">
                <a16:creationId xmlns:a16="http://schemas.microsoft.com/office/drawing/2014/main" id="{10754A8B-6964-2DD2-CFE9-D6CC96D3FC7C}"/>
              </a:ext>
            </a:extLst>
          </p:cNvPr>
          <p:cNvGrpSpPr/>
          <p:nvPr/>
        </p:nvGrpSpPr>
        <p:grpSpPr>
          <a:xfrm>
            <a:off x="521915" y="578070"/>
            <a:ext cx="2292898" cy="2248116"/>
            <a:chOff x="521915" y="551461"/>
            <a:chExt cx="2292898" cy="2248116"/>
          </a:xfrm>
        </p:grpSpPr>
        <p:pic>
          <p:nvPicPr>
            <p:cNvPr id="16" name="Picture 15" descr="A picture containing icon&#10;&#10;Description automatically generated">
              <a:extLst>
                <a:ext uri="{FF2B5EF4-FFF2-40B4-BE49-F238E27FC236}">
                  <a16:creationId xmlns:a16="http://schemas.microsoft.com/office/drawing/2014/main" id="{228D7AF4-7A5E-B269-AF98-8BB2E024F358}"/>
                </a:ext>
              </a:extLst>
            </p:cNvPr>
            <p:cNvPicPr>
              <a:picLocks noChangeAspect="1"/>
            </p:cNvPicPr>
            <p:nvPr/>
          </p:nvPicPr>
          <p:blipFill>
            <a:blip r:embed="rId2"/>
            <a:stretch>
              <a:fillRect/>
            </a:stretch>
          </p:blipFill>
          <p:spPr>
            <a:xfrm>
              <a:off x="801929" y="779425"/>
              <a:ext cx="2012884" cy="2020152"/>
            </a:xfrm>
            <a:prstGeom prst="rect">
              <a:avLst/>
            </a:prstGeom>
          </p:spPr>
        </p:pic>
        <p:sp>
          <p:nvSpPr>
            <p:cNvPr id="23" name="TextBox 22">
              <a:extLst>
                <a:ext uri="{FF2B5EF4-FFF2-40B4-BE49-F238E27FC236}">
                  <a16:creationId xmlns:a16="http://schemas.microsoft.com/office/drawing/2014/main" id="{36349FDA-333F-42AE-A0C4-1CB25F93DCF3}"/>
                </a:ext>
              </a:extLst>
            </p:cNvPr>
            <p:cNvSpPr txBox="1"/>
            <p:nvPr/>
          </p:nvSpPr>
          <p:spPr>
            <a:xfrm>
              <a:off x="521915" y="551461"/>
              <a:ext cx="295274" cy="276999"/>
            </a:xfrm>
            <a:prstGeom prst="rect">
              <a:avLst/>
            </a:prstGeom>
            <a:noFill/>
          </p:spPr>
          <p:txBody>
            <a:bodyPr wrap="none" rtlCol="0">
              <a:spAutoFit/>
            </a:bodyPr>
            <a:lstStyle/>
            <a:p>
              <a:r>
                <a:rPr lang="en-US" sz="1200" b="1">
                  <a:latin typeface="Arial" panose="020B0604020202020204" pitchFamily="34" charset="0"/>
                  <a:cs typeface="Arial" panose="020B0604020202020204" pitchFamily="34" charset="0"/>
                </a:rPr>
                <a:t>A</a:t>
              </a:r>
            </a:p>
          </p:txBody>
        </p:sp>
      </p:grpSp>
      <p:pic>
        <p:nvPicPr>
          <p:cNvPr id="22" name="Picture 21">
            <a:extLst>
              <a:ext uri="{FF2B5EF4-FFF2-40B4-BE49-F238E27FC236}">
                <a16:creationId xmlns:a16="http://schemas.microsoft.com/office/drawing/2014/main" id="{81FB5D99-E79B-9CC3-325B-F97AA8988D65}"/>
              </a:ext>
            </a:extLst>
          </p:cNvPr>
          <p:cNvPicPr>
            <a:picLocks noChangeAspect="1"/>
          </p:cNvPicPr>
          <p:nvPr/>
        </p:nvPicPr>
        <p:blipFill>
          <a:blip r:embed="rId3"/>
          <a:stretch>
            <a:fillRect/>
          </a:stretch>
        </p:blipFill>
        <p:spPr>
          <a:xfrm>
            <a:off x="5532481" y="290789"/>
            <a:ext cx="934278" cy="2745633"/>
          </a:xfrm>
          <a:prstGeom prst="rect">
            <a:avLst/>
          </a:prstGeom>
        </p:spPr>
      </p:pic>
      <p:grpSp>
        <p:nvGrpSpPr>
          <p:cNvPr id="27" name="Group 26">
            <a:extLst>
              <a:ext uri="{FF2B5EF4-FFF2-40B4-BE49-F238E27FC236}">
                <a16:creationId xmlns:a16="http://schemas.microsoft.com/office/drawing/2014/main" id="{7A21C120-B396-C956-112E-D10DE3D23846}"/>
              </a:ext>
            </a:extLst>
          </p:cNvPr>
          <p:cNvGrpSpPr/>
          <p:nvPr/>
        </p:nvGrpSpPr>
        <p:grpSpPr>
          <a:xfrm>
            <a:off x="2814813" y="559351"/>
            <a:ext cx="2636581" cy="2313330"/>
            <a:chOff x="2814813" y="559351"/>
            <a:chExt cx="2636581" cy="2313330"/>
          </a:xfrm>
        </p:grpSpPr>
        <p:pic>
          <p:nvPicPr>
            <p:cNvPr id="18" name="Picture 17" descr="A picture containing icon&#10;&#10;Description automatically generated">
              <a:extLst>
                <a:ext uri="{FF2B5EF4-FFF2-40B4-BE49-F238E27FC236}">
                  <a16:creationId xmlns:a16="http://schemas.microsoft.com/office/drawing/2014/main" id="{BC80236D-B531-B1B5-C160-D060D1D4E596}"/>
                </a:ext>
              </a:extLst>
            </p:cNvPr>
            <p:cNvPicPr>
              <a:picLocks noChangeAspect="1"/>
            </p:cNvPicPr>
            <p:nvPr/>
          </p:nvPicPr>
          <p:blipFill>
            <a:blip r:embed="rId4"/>
            <a:stretch>
              <a:fillRect/>
            </a:stretch>
          </p:blipFill>
          <p:spPr>
            <a:xfrm>
              <a:off x="2874280" y="957742"/>
              <a:ext cx="2577114" cy="1914939"/>
            </a:xfrm>
            <a:prstGeom prst="rect">
              <a:avLst/>
            </a:prstGeom>
          </p:spPr>
        </p:pic>
        <p:sp>
          <p:nvSpPr>
            <p:cNvPr id="25" name="TextBox 24">
              <a:extLst>
                <a:ext uri="{FF2B5EF4-FFF2-40B4-BE49-F238E27FC236}">
                  <a16:creationId xmlns:a16="http://schemas.microsoft.com/office/drawing/2014/main" id="{57348ADA-C428-9209-0E08-3BE3EE1DDF77}"/>
                </a:ext>
              </a:extLst>
            </p:cNvPr>
            <p:cNvSpPr txBox="1"/>
            <p:nvPr/>
          </p:nvSpPr>
          <p:spPr>
            <a:xfrm>
              <a:off x="2814813" y="559351"/>
              <a:ext cx="295274" cy="276999"/>
            </a:xfrm>
            <a:prstGeom prst="rect">
              <a:avLst/>
            </a:prstGeom>
            <a:noFill/>
          </p:spPr>
          <p:txBody>
            <a:bodyPr wrap="none" rtlCol="0">
              <a:spAutoFit/>
            </a:bodyPr>
            <a:lstStyle/>
            <a:p>
              <a:r>
                <a:rPr lang="en-US" sz="1200" b="1">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33269527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TotalTime>
  <Words>183</Words>
  <Application>Microsoft Office PowerPoint</Application>
  <PresentationFormat>Custom</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hakal, Alfa</dc:creator>
  <cp:lastModifiedBy>Salim, Chinnu</cp:lastModifiedBy>
  <cp:revision>79</cp:revision>
  <cp:lastPrinted>2023-01-31T14:45:13Z</cp:lastPrinted>
  <dcterms:created xsi:type="dcterms:W3CDTF">2022-10-06T21:20:44Z</dcterms:created>
  <dcterms:modified xsi:type="dcterms:W3CDTF">2023-11-27T14:49:31Z</dcterms:modified>
</cp:coreProperties>
</file>